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2309" y="6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10/03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3" Type="http://schemas.openxmlformats.org/officeDocument/2006/relationships/image" Target="../media/image2.emf"/><Relationship Id="rId7" Type="http://schemas.microsoft.com/office/2007/relationships/hdphoto" Target="../media/hdphoto2.wdp"/><Relationship Id="rId12" Type="http://schemas.microsoft.com/office/2007/relationships/hdphoto" Target="../media/hdphoto4.wdp"/><Relationship Id="rId17" Type="http://schemas.openxmlformats.org/officeDocument/2006/relationships/image" Target="../media/image11.emf"/><Relationship Id="rId2" Type="http://schemas.openxmlformats.org/officeDocument/2006/relationships/image" Target="../media/image1.emf"/><Relationship Id="rId16" Type="http://schemas.openxmlformats.org/officeDocument/2006/relationships/image" Target="../media/image1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microsoft.com/office/2007/relationships/hdphoto" Target="../media/hdphoto1.wdp"/><Relationship Id="rId15" Type="http://schemas.openxmlformats.org/officeDocument/2006/relationships/image" Target="../media/image9.emf"/><Relationship Id="rId10" Type="http://schemas.microsoft.com/office/2007/relationships/hdphoto" Target="../media/hdphoto3.wdp"/><Relationship Id="rId4" Type="http://schemas.openxmlformats.org/officeDocument/2006/relationships/image" Target="../media/image3.png"/><Relationship Id="rId9" Type="http://schemas.openxmlformats.org/officeDocument/2006/relationships/image" Target="../media/image6.png"/><Relationship Id="rId1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37 CuadroTexto"/>
          <p:cNvSpPr txBox="1"/>
          <p:nvPr/>
        </p:nvSpPr>
        <p:spPr>
          <a:xfrm>
            <a:off x="332657" y="6963407"/>
            <a:ext cx="612068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i="1" dirty="0" err="1" smtClean="0"/>
              <a:t>Supplementary</a:t>
            </a:r>
            <a:r>
              <a:rPr lang="es-ES" sz="1200" b="1" i="1" dirty="0" smtClean="0"/>
              <a:t> figure 2</a:t>
            </a:r>
            <a:r>
              <a:rPr lang="es-ES" sz="1200" i="1" dirty="0" smtClean="0"/>
              <a:t>. </a:t>
            </a:r>
            <a:r>
              <a:rPr lang="en-GB" sz="1200" b="1" dirty="0"/>
              <a:t>Characterization of MIA PaCa-2 cells after depletion of miR-93 by CRISPR/Cas9.</a:t>
            </a:r>
            <a:r>
              <a:rPr lang="en-GB" sz="1200" dirty="0"/>
              <a:t> A) Schematic representation of the miR-106b-25 cluster and the CRISPR/Cas9 strategy for miR-93 depletion in MIA PaCa-2 cells. B) MiR-93 expression analysis by </a:t>
            </a:r>
            <a:r>
              <a:rPr lang="en-GB" sz="1200" dirty="0" err="1"/>
              <a:t>qRT</a:t>
            </a:r>
            <a:r>
              <a:rPr lang="en-GB" sz="1200" dirty="0"/>
              <a:t>-PCR in MIA PaCa-2 Control or KO-miR-93 cells, n=2; C) Optical microscope images. Scale bars 10µm, magnitude 10x. D) Doubling time of MIA PACa-2 cells with or without miR-93 in hours, n=3; C1: clone1 and C2: clone2 . E) MTS assay to show the effects of miR-93 depletion on MIA PaCa-2 cell proliferation and viability (n=3).  F) </a:t>
            </a:r>
            <a:r>
              <a:rPr lang="en-GB" sz="1200" dirty="0" err="1"/>
              <a:t>Transwell</a:t>
            </a:r>
            <a:r>
              <a:rPr lang="en-GB" sz="1200" dirty="0"/>
              <a:t> invasion assay of MIA PaCa-2 KO-miR-93 cells compared with MIA PaCa-2 Control cells (n=3). Statistics for number of invading cells per insert, representative images of the analysed conditions magnitude 4x, scale bars 100µm. Error bars=</a:t>
            </a:r>
            <a:r>
              <a:rPr lang="en-GB" sz="1200" dirty="0" err="1"/>
              <a:t>s.d.</a:t>
            </a:r>
            <a:r>
              <a:rPr lang="en-GB" sz="1200" dirty="0"/>
              <a:t>; *p</a:t>
            </a:r>
            <a:r>
              <a:rPr lang="en-GB" sz="1200" dirty="0">
                <a:sym typeface="Symbol"/>
              </a:rPr>
              <a:t></a:t>
            </a:r>
            <a:r>
              <a:rPr lang="en-GB" sz="1200" dirty="0"/>
              <a:t>0.05 **p</a:t>
            </a:r>
            <a:r>
              <a:rPr lang="en-GB" sz="1200" dirty="0">
                <a:sym typeface="Symbol"/>
              </a:rPr>
              <a:t></a:t>
            </a:r>
            <a:r>
              <a:rPr lang="en-GB" sz="1200" dirty="0"/>
              <a:t>0.01; *** p</a:t>
            </a:r>
            <a:r>
              <a:rPr lang="en-GB" sz="1200" dirty="0">
                <a:sym typeface="Symbol"/>
              </a:rPr>
              <a:t></a:t>
            </a:r>
            <a:r>
              <a:rPr lang="en-GB" sz="1200" dirty="0"/>
              <a:t> 0.001</a:t>
            </a:r>
            <a:r>
              <a:rPr lang="en-GB" sz="1200" dirty="0" smtClean="0"/>
              <a:t>.</a:t>
            </a:r>
            <a:endParaRPr lang="es-ES" sz="1200" dirty="0"/>
          </a:p>
        </p:txBody>
      </p:sp>
      <p:grpSp>
        <p:nvGrpSpPr>
          <p:cNvPr id="2" name="1 Grupo"/>
          <p:cNvGrpSpPr/>
          <p:nvPr/>
        </p:nvGrpSpPr>
        <p:grpSpPr>
          <a:xfrm>
            <a:off x="1234426" y="323528"/>
            <a:ext cx="3770879" cy="1558833"/>
            <a:chOff x="1992434" y="116633"/>
            <a:chExt cx="5027838" cy="2002579"/>
          </a:xfrm>
        </p:grpSpPr>
        <p:sp>
          <p:nvSpPr>
            <p:cNvPr id="33" name="32 CuadroTexto"/>
            <p:cNvSpPr txBox="1"/>
            <p:nvPr/>
          </p:nvSpPr>
          <p:spPr>
            <a:xfrm>
              <a:off x="1992434" y="176582"/>
              <a:ext cx="487741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smtClean="0"/>
                <a:t>A)</a:t>
              </a:r>
              <a:endParaRPr lang="es-ES" sz="1600" dirty="0"/>
            </a:p>
          </p:txBody>
        </p:sp>
        <p:pic>
          <p:nvPicPr>
            <p:cNvPr id="39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02901" y="116633"/>
              <a:ext cx="4517371" cy="200257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16" name="15 Grupo"/>
          <p:cNvGrpSpPr/>
          <p:nvPr/>
        </p:nvGrpSpPr>
        <p:grpSpPr>
          <a:xfrm>
            <a:off x="298398" y="2123728"/>
            <a:ext cx="6146528" cy="4476320"/>
            <a:chOff x="298398" y="2123728"/>
            <a:chExt cx="6146528" cy="4476320"/>
          </a:xfrm>
        </p:grpSpPr>
        <p:sp>
          <p:nvSpPr>
            <p:cNvPr id="8" name="Text Box 178">
              <a:extLst>
                <a:ext uri="{FF2B5EF4-FFF2-40B4-BE49-F238E27FC236}">
                  <a16:creationId xmlns:a16="http://schemas.microsoft.com/office/drawing/2014/main" xmlns="" id="{9F17D0A6-D9C5-4F6C-8BC1-3A06BA8282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91425" y="3697035"/>
              <a:ext cx="1746122" cy="2567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 fontAlgn="base">
                <a:spcBef>
                  <a:spcPts val="1080"/>
                </a:spcBef>
              </a:pPr>
              <a:r>
                <a:rPr lang="en-US" sz="1000" b="1" dirty="0" smtClean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MIA PaCa-2 KO-miR-93 C2</a:t>
              </a:r>
              <a:endPara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9" name="Text Box 172">
              <a:extLst>
                <a:ext uri="{FF2B5EF4-FFF2-40B4-BE49-F238E27FC236}">
                  <a16:creationId xmlns:a16="http://schemas.microsoft.com/office/drawing/2014/main" xmlns="" id="{5101644E-4FBA-4B77-8C8F-FCFDE55352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1093985" y="3687281"/>
              <a:ext cx="1281571" cy="1886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 fontAlgn="base">
                <a:spcBef>
                  <a:spcPts val="1080"/>
                </a:spcBef>
              </a:pPr>
              <a:r>
                <a:rPr lang="en-US" sz="1000" b="1" dirty="0" smtClean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MIA PaCa-2 </a:t>
              </a:r>
              <a:r>
                <a:rPr lang="en-US" sz="10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Control</a:t>
              </a:r>
              <a:endPara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0" name="Text Box 178">
              <a:extLst>
                <a:ext uri="{FF2B5EF4-FFF2-40B4-BE49-F238E27FC236}">
                  <a16:creationId xmlns:a16="http://schemas.microsoft.com/office/drawing/2014/main" xmlns="" id="{82E95D8E-ED97-4333-9145-AD6393000E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68939" y="3685493"/>
              <a:ext cx="1785543" cy="2567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 fontAlgn="base">
                <a:spcBef>
                  <a:spcPts val="1080"/>
                </a:spcBef>
              </a:pPr>
              <a:r>
                <a:rPr lang="en-US" sz="1000" b="1" dirty="0" smtClean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MIA PaCa-2 KO-miR-93  C1</a:t>
              </a:r>
              <a:endPara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4" name="33 CuadroTexto"/>
            <p:cNvSpPr txBox="1"/>
            <p:nvPr/>
          </p:nvSpPr>
          <p:spPr>
            <a:xfrm>
              <a:off x="346934" y="2284726"/>
              <a:ext cx="397847" cy="244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B</a:t>
              </a:r>
              <a:r>
                <a:rPr lang="es-ES" sz="1600" dirty="0" smtClean="0"/>
                <a:t>)</a:t>
              </a:r>
              <a:endParaRPr lang="es-ES" sz="1600" dirty="0"/>
            </a:p>
          </p:txBody>
        </p:sp>
        <p:sp>
          <p:nvSpPr>
            <p:cNvPr id="36" name="35 CuadroTexto"/>
            <p:cNvSpPr txBox="1"/>
            <p:nvPr/>
          </p:nvSpPr>
          <p:spPr>
            <a:xfrm>
              <a:off x="298398" y="3646997"/>
              <a:ext cx="394297" cy="244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smtClean="0"/>
                <a:t>C)</a:t>
              </a:r>
              <a:endParaRPr lang="es-ES" sz="1600" dirty="0"/>
            </a:p>
          </p:txBody>
        </p:sp>
        <p:sp>
          <p:nvSpPr>
            <p:cNvPr id="29" name="28 CuadroTexto"/>
            <p:cNvSpPr txBox="1"/>
            <p:nvPr/>
          </p:nvSpPr>
          <p:spPr>
            <a:xfrm>
              <a:off x="4186326" y="2328170"/>
              <a:ext cx="385424" cy="244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smtClean="0"/>
                <a:t>E)</a:t>
              </a:r>
              <a:endParaRPr lang="es-ES" sz="1600" dirty="0"/>
            </a:p>
          </p:txBody>
        </p:sp>
        <p:sp>
          <p:nvSpPr>
            <p:cNvPr id="40" name="Text Box 178">
              <a:extLst>
                <a:ext uri="{FF2B5EF4-FFF2-40B4-BE49-F238E27FC236}">
                  <a16:creationId xmlns:a16="http://schemas.microsoft.com/office/drawing/2014/main" xmlns="" id="{9F17D0A6-D9C5-4F6C-8BC1-3A06BA8282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69160" y="5370148"/>
              <a:ext cx="1414692" cy="2567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 fontAlgn="base">
                <a:spcBef>
                  <a:spcPts val="1080"/>
                </a:spcBef>
              </a:pPr>
              <a:r>
                <a:rPr lang="en-US" sz="850" b="1" dirty="0" smtClean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MIA PaCa-2 KO-miR-93 C2 </a:t>
              </a:r>
              <a:r>
                <a:rPr lang="en-US" sz="85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Clone 2</a:t>
              </a:r>
              <a:endParaRPr lang="en-GB" sz="85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1" name="Text Box 178">
              <a:extLst>
                <a:ext uri="{FF2B5EF4-FFF2-40B4-BE49-F238E27FC236}">
                  <a16:creationId xmlns:a16="http://schemas.microsoft.com/office/drawing/2014/main" xmlns="" id="{82E95D8E-ED97-4333-9145-AD6393000E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3016" y="5370148"/>
              <a:ext cx="1457127" cy="2567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 fontAlgn="base">
                <a:spcBef>
                  <a:spcPts val="1080"/>
                </a:spcBef>
              </a:pPr>
              <a:r>
                <a:rPr lang="en-US" sz="850" b="1" dirty="0" smtClean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MIA PaCa-2 KO-miR-93 C1  </a:t>
              </a:r>
              <a:r>
                <a:rPr lang="en-US" sz="85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Clone 1</a:t>
              </a:r>
              <a:endParaRPr lang="en-GB" sz="85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2" name="Text Box 172">
              <a:extLst>
                <a:ext uri="{FF2B5EF4-FFF2-40B4-BE49-F238E27FC236}">
                  <a16:creationId xmlns:a16="http://schemas.microsoft.com/office/drawing/2014/main" xmlns="" id="{5101644E-4FBA-4B77-8C8F-FCFDE55352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0800000">
              <a:off x="2446170" y="5377820"/>
              <a:ext cx="1222862" cy="1886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ctr" fontAlgn="base">
                <a:spcBef>
                  <a:spcPts val="1080"/>
                </a:spcBef>
              </a:pPr>
              <a:r>
                <a:rPr lang="en-US" sz="900" b="1" dirty="0" smtClean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MIA PaCa-2 </a:t>
              </a:r>
              <a:r>
                <a:rPr lang="en-US" sz="9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Microsoft Sans Serif" panose="020B0604020202020204" pitchFamily="34" charset="0"/>
                </a:rPr>
                <a:t>Control</a:t>
              </a:r>
              <a:endParaRPr lang="en-GB" sz="90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7" name="36 CuadroTexto"/>
            <p:cNvSpPr txBox="1"/>
            <p:nvPr/>
          </p:nvSpPr>
          <p:spPr>
            <a:xfrm>
              <a:off x="339361" y="5266790"/>
              <a:ext cx="665200" cy="2446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dirty="0" smtClean="0"/>
                <a:t>F)</a:t>
              </a:r>
              <a:endParaRPr lang="es-ES" sz="1600" dirty="0"/>
            </a:p>
          </p:txBody>
        </p:sp>
        <p:pic>
          <p:nvPicPr>
            <p:cNvPr id="3076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7" t="2328" r="1333" b="3158"/>
            <a:stretch/>
          </p:blipFill>
          <p:spPr bwMode="auto">
            <a:xfrm>
              <a:off x="4480907" y="2189387"/>
              <a:ext cx="1964019" cy="15468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2"/>
            <p:cNvPicPr>
              <a:picLocks noChangeAspect="1" noChangeArrowheads="1"/>
            </p:cNvPicPr>
            <p:nvPr/>
          </p:nvPicPr>
          <p:blipFill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5993" y="5583752"/>
              <a:ext cx="1218859" cy="9121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8" name="Picture 6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27435" y="5583752"/>
              <a:ext cx="1222886" cy="9075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9" name="Picture 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02600" y="5585520"/>
              <a:ext cx="1221673" cy="9057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82" name="Picture 10" descr="E:\IDIBAPS\Paper_miR93\Images_Clones_MiaP_miR93\Images_Clones_MiaP_miR93\scale\MiaEC_50um_20x_20_12_19_B_scale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2837" y="3936388"/>
              <a:ext cx="1442353" cy="11535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83" name="Picture 11" descr="E:\IDIBAPS\Paper_miR93\Images_Clones_MiaP_miR93\Images_Clones_MiaP_miR93\scale\MiaC4_lowp_50um_20x_20_12_19_B_scale.tif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76127" y="3938385"/>
              <a:ext cx="1437214" cy="11515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84" name="Picture 12" descr="E:\IDIBAPS\Paper_miR93\Images_Clones_MiaP_miR93\Images_Clones_MiaP_miR93\scale\MiaC7_50um_20x_20_12_19_c_scale.tif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48316" y="3908821"/>
              <a:ext cx="1479200" cy="118111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5402" y="2123728"/>
              <a:ext cx="1515911" cy="15400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26 CuadroTexto"/>
            <p:cNvSpPr txBox="1"/>
            <p:nvPr/>
          </p:nvSpPr>
          <p:spPr>
            <a:xfrm>
              <a:off x="5950043" y="2606297"/>
              <a:ext cx="4084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/>
                <a:t>***</a:t>
              </a:r>
              <a:endParaRPr lang="es-ES" sz="800" dirty="0"/>
            </a:p>
          </p:txBody>
        </p:sp>
        <p:sp>
          <p:nvSpPr>
            <p:cNvPr id="28" name="27 CuadroTexto"/>
            <p:cNvSpPr txBox="1"/>
            <p:nvPr/>
          </p:nvSpPr>
          <p:spPr>
            <a:xfrm>
              <a:off x="5949281" y="2825035"/>
              <a:ext cx="3795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/>
                <a:t>***</a:t>
              </a:r>
              <a:endParaRPr lang="es-ES" sz="800" dirty="0"/>
            </a:p>
          </p:txBody>
        </p:sp>
        <p:sp>
          <p:nvSpPr>
            <p:cNvPr id="30" name="29 CuadroTexto"/>
            <p:cNvSpPr txBox="1"/>
            <p:nvPr/>
          </p:nvSpPr>
          <p:spPr>
            <a:xfrm>
              <a:off x="5576139" y="2937325"/>
              <a:ext cx="3540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/>
                <a:t>***</a:t>
              </a:r>
              <a:endParaRPr lang="es-ES" sz="800" dirty="0"/>
            </a:p>
          </p:txBody>
        </p:sp>
        <p:sp>
          <p:nvSpPr>
            <p:cNvPr id="31" name="30 CuadroTexto"/>
            <p:cNvSpPr txBox="1"/>
            <p:nvPr/>
          </p:nvSpPr>
          <p:spPr>
            <a:xfrm>
              <a:off x="5576519" y="3131840"/>
              <a:ext cx="3540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/>
                <a:t>***</a:t>
              </a:r>
              <a:endParaRPr lang="es-ES" sz="800" dirty="0"/>
            </a:p>
          </p:txBody>
        </p:sp>
        <p:sp>
          <p:nvSpPr>
            <p:cNvPr id="32" name="31 CuadroTexto"/>
            <p:cNvSpPr txBox="1"/>
            <p:nvPr/>
          </p:nvSpPr>
          <p:spPr>
            <a:xfrm>
              <a:off x="5249241" y="3102996"/>
              <a:ext cx="292672" cy="2446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/>
                <a:t>**</a:t>
              </a:r>
              <a:endParaRPr lang="es-ES" sz="800" dirty="0"/>
            </a:p>
          </p:txBody>
        </p:sp>
        <p:sp>
          <p:nvSpPr>
            <p:cNvPr id="44" name="43 CuadroTexto"/>
            <p:cNvSpPr txBox="1"/>
            <p:nvPr/>
          </p:nvSpPr>
          <p:spPr>
            <a:xfrm>
              <a:off x="5249241" y="3216243"/>
              <a:ext cx="292672" cy="2446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/>
                <a:t>**</a:t>
              </a:r>
              <a:endParaRPr lang="es-ES" sz="800" dirty="0"/>
            </a:p>
          </p:txBody>
        </p:sp>
        <p:grpSp>
          <p:nvGrpSpPr>
            <p:cNvPr id="26" name="25 Grupo"/>
            <p:cNvGrpSpPr/>
            <p:nvPr/>
          </p:nvGrpSpPr>
          <p:grpSpPr>
            <a:xfrm>
              <a:off x="818513" y="5266791"/>
              <a:ext cx="1441517" cy="1333257"/>
              <a:chOff x="1683616" y="5398276"/>
              <a:chExt cx="1736257" cy="1383516"/>
            </a:xfrm>
          </p:grpSpPr>
          <p:pic>
            <p:nvPicPr>
              <p:cNvPr id="3081" name="Picture 9"/>
              <p:cNvPicPr>
                <a:picLocks noChangeAspect="1" noChangeArrowheads="1"/>
              </p:cNvPicPr>
              <p:nvPr/>
            </p:nvPicPr>
            <p:blipFill rotWithShape="1">
              <a:blip r:embed="rId16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9" t="-1" r="657" b="8737"/>
              <a:stretch/>
            </p:blipFill>
            <p:spPr bwMode="auto">
              <a:xfrm>
                <a:off x="1683616" y="5398276"/>
                <a:ext cx="1736257" cy="138351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9" name="48 CuadroTexto"/>
              <p:cNvSpPr txBox="1"/>
              <p:nvPr/>
            </p:nvSpPr>
            <p:spPr>
              <a:xfrm>
                <a:off x="2949464" y="5468986"/>
                <a:ext cx="352513" cy="253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/>
                  <a:t>**</a:t>
                </a:r>
                <a:endParaRPr lang="es-ES" sz="800" dirty="0"/>
              </a:p>
            </p:txBody>
          </p:sp>
          <p:cxnSp>
            <p:nvCxnSpPr>
              <p:cNvPr id="15" name="14 Conector recto"/>
              <p:cNvCxnSpPr/>
              <p:nvPr/>
            </p:nvCxnSpPr>
            <p:spPr>
              <a:xfrm>
                <a:off x="2157063" y="5611365"/>
                <a:ext cx="941445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49 Conector recto"/>
              <p:cNvCxnSpPr/>
              <p:nvPr/>
            </p:nvCxnSpPr>
            <p:spPr>
              <a:xfrm>
                <a:off x="2157062" y="5638760"/>
                <a:ext cx="470722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55 Conector recto"/>
              <p:cNvCxnSpPr/>
              <p:nvPr/>
            </p:nvCxnSpPr>
            <p:spPr>
              <a:xfrm>
                <a:off x="3098506" y="5611365"/>
                <a:ext cx="0" cy="2659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58 Conector recto"/>
              <p:cNvCxnSpPr/>
              <p:nvPr/>
            </p:nvCxnSpPr>
            <p:spPr>
              <a:xfrm>
                <a:off x="2627783" y="5638759"/>
                <a:ext cx="0" cy="183395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62 CuadroTexto"/>
              <p:cNvSpPr txBox="1"/>
              <p:nvPr/>
            </p:nvSpPr>
            <p:spPr>
              <a:xfrm>
                <a:off x="2470899" y="5459837"/>
                <a:ext cx="352513" cy="253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/>
                  <a:t>**</a:t>
                </a:r>
                <a:endParaRPr lang="es-ES" sz="800" dirty="0"/>
              </a:p>
            </p:txBody>
          </p:sp>
        </p:grpSp>
      </p:grpSp>
      <p:grpSp>
        <p:nvGrpSpPr>
          <p:cNvPr id="14" name="13 Grupo"/>
          <p:cNvGrpSpPr/>
          <p:nvPr/>
        </p:nvGrpSpPr>
        <p:grpSpPr>
          <a:xfrm>
            <a:off x="2343157" y="2127252"/>
            <a:ext cx="1770184" cy="1536544"/>
            <a:chOff x="2343157" y="2127252"/>
            <a:chExt cx="1770184" cy="1536544"/>
          </a:xfrm>
        </p:grpSpPr>
        <p:sp>
          <p:nvSpPr>
            <p:cNvPr id="35" name="34 CuadroTexto"/>
            <p:cNvSpPr txBox="1"/>
            <p:nvPr/>
          </p:nvSpPr>
          <p:spPr>
            <a:xfrm>
              <a:off x="2343157" y="2298285"/>
              <a:ext cx="413816" cy="2446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/>
                <a:t>D</a:t>
              </a:r>
              <a:r>
                <a:rPr lang="es-ES" sz="1600" dirty="0" smtClean="0"/>
                <a:t>)</a:t>
              </a:r>
              <a:endParaRPr lang="es-ES" sz="1600" dirty="0"/>
            </a:p>
          </p:txBody>
        </p:sp>
        <p:grpSp>
          <p:nvGrpSpPr>
            <p:cNvPr id="13" name="12 Grupo"/>
            <p:cNvGrpSpPr/>
            <p:nvPr/>
          </p:nvGrpSpPr>
          <p:grpSpPr>
            <a:xfrm>
              <a:off x="2601818" y="2127252"/>
              <a:ext cx="1511523" cy="1536544"/>
              <a:chOff x="3831544" y="2140388"/>
              <a:chExt cx="1820576" cy="1594469"/>
            </a:xfrm>
          </p:grpSpPr>
          <p:pic>
            <p:nvPicPr>
              <p:cNvPr id="3077" name="Picture 5"/>
              <p:cNvPicPr>
                <a:picLocks noChangeAspect="1" noChangeArrowheads="1"/>
              </p:cNvPicPr>
              <p:nvPr/>
            </p:nvPicPr>
            <p:blipFill rotWithShape="1">
              <a:blip r:embed="rId17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" t="1710" r="2287" b="586"/>
              <a:stretch/>
            </p:blipFill>
            <p:spPr bwMode="auto">
              <a:xfrm>
                <a:off x="3831544" y="2204865"/>
                <a:ext cx="1820576" cy="15299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" name="2 Conector recto"/>
              <p:cNvCxnSpPr/>
              <p:nvPr/>
            </p:nvCxnSpPr>
            <p:spPr>
              <a:xfrm flipV="1">
                <a:off x="4380518" y="2276872"/>
                <a:ext cx="0" cy="446118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44 Conector recto"/>
              <p:cNvCxnSpPr/>
              <p:nvPr/>
            </p:nvCxnSpPr>
            <p:spPr>
              <a:xfrm flipH="1">
                <a:off x="4380518" y="2276872"/>
                <a:ext cx="1031036" cy="1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10 Conector recto"/>
              <p:cNvCxnSpPr/>
              <p:nvPr/>
            </p:nvCxnSpPr>
            <p:spPr>
              <a:xfrm flipV="1">
                <a:off x="4891448" y="2430756"/>
                <a:ext cx="0" cy="206735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45 Conector recto"/>
              <p:cNvCxnSpPr/>
              <p:nvPr/>
            </p:nvCxnSpPr>
            <p:spPr>
              <a:xfrm flipH="1">
                <a:off x="4385022" y="2435621"/>
                <a:ext cx="501837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46 CuadroTexto"/>
              <p:cNvSpPr txBox="1"/>
              <p:nvPr/>
            </p:nvSpPr>
            <p:spPr>
              <a:xfrm>
                <a:off x="4741124" y="2140388"/>
                <a:ext cx="352513" cy="253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/>
                  <a:t>**</a:t>
                </a:r>
                <a:endParaRPr lang="es-ES" sz="800" dirty="0"/>
              </a:p>
            </p:txBody>
          </p:sp>
          <p:sp>
            <p:nvSpPr>
              <p:cNvPr id="48" name="47 CuadroTexto"/>
              <p:cNvSpPr txBox="1"/>
              <p:nvPr/>
            </p:nvSpPr>
            <p:spPr>
              <a:xfrm>
                <a:off x="4480931" y="2286176"/>
                <a:ext cx="352513" cy="1615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 smtClean="0"/>
                  <a:t>*</a:t>
                </a:r>
                <a:endParaRPr lang="es-ES" sz="800" dirty="0"/>
              </a:p>
            </p:txBody>
          </p:sp>
        </p:grpSp>
        <p:cxnSp>
          <p:nvCxnSpPr>
            <p:cNvPr id="51" name="50 Conector recto"/>
            <p:cNvCxnSpPr/>
            <p:nvPr/>
          </p:nvCxnSpPr>
          <p:spPr>
            <a:xfrm flipV="1">
              <a:off x="3917816" y="2260125"/>
              <a:ext cx="0" cy="60425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05344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218</Words>
  <Application>Microsoft Office PowerPoint</Application>
  <PresentationFormat>Presentación en pantalla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EZ, ELENA (IDIBAPS)</dc:creator>
  <cp:lastModifiedBy>GIRONELLA, MERITXELL (ICMDM)</cp:lastModifiedBy>
  <cp:revision>12</cp:revision>
  <dcterms:created xsi:type="dcterms:W3CDTF">2020-02-25T11:48:59Z</dcterms:created>
  <dcterms:modified xsi:type="dcterms:W3CDTF">2020-03-10T09:34:27Z</dcterms:modified>
</cp:coreProperties>
</file>